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71">
          <p15:clr>
            <a:srgbClr val="A4A3A4"/>
          </p15:clr>
        </p15:guide>
        <p15:guide id="2" pos="298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0FF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napToObjects="1" showGuides="1">
      <p:cViewPr varScale="1">
        <p:scale>
          <a:sx n="62" d="100"/>
          <a:sy n="62" d="100"/>
        </p:scale>
        <p:origin x="652" y="48"/>
      </p:cViewPr>
      <p:guideLst>
        <p:guide orient="horz" pos="2171"/>
        <p:guide pos="298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451E2D-06B3-A14A-BADF-1A9EA4A59415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4694A4-5CF1-944E-A3E9-6890100CEA5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3287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543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4745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1097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097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334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08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2771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755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140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3290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708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8489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44753041"/>
              </p:ext>
            </p:extLst>
          </p:nvPr>
        </p:nvGraphicFramePr>
        <p:xfrm>
          <a:off x="863600" y="2871311"/>
          <a:ext cx="7416800" cy="1983740"/>
        </p:xfrm>
        <a:graphic>
          <a:graphicData uri="http://schemas.openxmlformats.org/drawingml/2006/table">
            <a:tbl>
              <a:tblPr/>
              <a:tblGrid>
                <a:gridCol w="24638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i="0" u="none" strike="noStrike" dirty="0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COVID-19 IMPACT FROM 2022 TO 202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Tota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%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Aliv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  %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Dea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 %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ortality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2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.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2.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.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2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2.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.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3.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ospitalization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2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.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6.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2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.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6.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6.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-65315" y="0"/>
            <a:ext cx="58106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Table 3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verall mortality and hospitalization rate from 2022 to 2023</a:t>
            </a:r>
          </a:p>
        </p:txBody>
      </p:sp>
    </p:spTree>
    <p:extLst>
      <p:ext uri="{BB962C8B-B14F-4D97-AF65-F5344CB8AC3E}">
        <p14:creationId xmlns:p14="http://schemas.microsoft.com/office/powerpoint/2010/main" val="39034996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1</Words>
  <Application>Microsoft Office PowerPoint</Application>
  <PresentationFormat>Presentazione su schermo (4:3)</PresentationFormat>
  <Paragraphs>6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e</dc:creator>
  <cp:lastModifiedBy>Daniele Caracciolo</cp:lastModifiedBy>
  <cp:revision>108</cp:revision>
  <dcterms:created xsi:type="dcterms:W3CDTF">2024-10-12T13:22:48Z</dcterms:created>
  <dcterms:modified xsi:type="dcterms:W3CDTF">2025-05-25T19:56:38Z</dcterms:modified>
</cp:coreProperties>
</file>